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7" r:id="rId2"/>
    <p:sldId id="256" r:id="rId3"/>
    <p:sldId id="258" r:id="rId4"/>
    <p:sldId id="261" r:id="rId5"/>
    <p:sldId id="259" r:id="rId6"/>
    <p:sldId id="260" r:id="rId7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D2644AF-49FD-466A-B4F1-5B35D3C2BFBB}" v="21" dt="2021-03-26T23:18:39.27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5" d="100"/>
          <a:sy n="65" d="100"/>
        </p:scale>
        <p:origin x="2453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rah Hill" userId="b774f213905f0ee8" providerId="LiveId" clId="{4D2644AF-49FD-466A-B4F1-5B35D3C2BFBB}"/>
    <pc:docChg chg="undo custSel addSld modSld modMainMaster">
      <pc:chgData name="Sarah Hill" userId="b774f213905f0ee8" providerId="LiveId" clId="{4D2644AF-49FD-466A-B4F1-5B35D3C2BFBB}" dt="2021-03-26T23:19:23.823" v="690" actId="20577"/>
      <pc:docMkLst>
        <pc:docMk/>
      </pc:docMkLst>
      <pc:sldChg chg="addSp delSp modSp mod">
        <pc:chgData name="Sarah Hill" userId="b774f213905f0ee8" providerId="LiveId" clId="{4D2644AF-49FD-466A-B4F1-5B35D3C2BFBB}" dt="2021-03-25T12:21:07.274" v="632" actId="478"/>
        <pc:sldMkLst>
          <pc:docMk/>
          <pc:sldMk cId="1069951532" sldId="256"/>
        </pc:sldMkLst>
        <pc:spChg chg="del mod">
          <ac:chgData name="Sarah Hill" userId="b774f213905f0ee8" providerId="LiveId" clId="{4D2644AF-49FD-466A-B4F1-5B35D3C2BFBB}" dt="2021-03-25T05:32:50.523" v="1" actId="478"/>
          <ac:spMkLst>
            <pc:docMk/>
            <pc:sldMk cId="1069951532" sldId="256"/>
            <ac:spMk id="2" creationId="{C69BBA81-327F-4A46-B1F4-D593099CB956}"/>
          </ac:spMkLst>
        </pc:spChg>
        <pc:spChg chg="del mod">
          <ac:chgData name="Sarah Hill" userId="b774f213905f0ee8" providerId="LiveId" clId="{4D2644AF-49FD-466A-B4F1-5B35D3C2BFBB}" dt="2021-03-25T05:32:52.153" v="2" actId="478"/>
          <ac:spMkLst>
            <pc:docMk/>
            <pc:sldMk cId="1069951532" sldId="256"/>
            <ac:spMk id="3" creationId="{5BB040FA-8003-4D98-ABB0-1C6A17D10738}"/>
          </ac:spMkLst>
        </pc:spChg>
        <pc:spChg chg="add mod">
          <ac:chgData name="Sarah Hill" userId="b774f213905f0ee8" providerId="LiveId" clId="{4D2644AF-49FD-466A-B4F1-5B35D3C2BFBB}" dt="2021-03-25T05:34:23.257" v="56" actId="1035"/>
          <ac:spMkLst>
            <pc:docMk/>
            <pc:sldMk cId="1069951532" sldId="256"/>
            <ac:spMk id="6" creationId="{6F8F25D2-4CD1-4860-895F-6E960C95043B}"/>
          </ac:spMkLst>
        </pc:spChg>
        <pc:spChg chg="add del mod">
          <ac:chgData name="Sarah Hill" userId="b774f213905f0ee8" providerId="LiveId" clId="{4D2644AF-49FD-466A-B4F1-5B35D3C2BFBB}" dt="2021-03-25T12:21:07.274" v="632" actId="478"/>
          <ac:spMkLst>
            <pc:docMk/>
            <pc:sldMk cId="1069951532" sldId="256"/>
            <ac:spMk id="7" creationId="{4FDC8D24-01BD-4C4D-BDA6-30551BA6806F}"/>
          </ac:spMkLst>
        </pc:spChg>
        <pc:spChg chg="add mod">
          <ac:chgData name="Sarah Hill" userId="b774f213905f0ee8" providerId="LiveId" clId="{4D2644AF-49FD-466A-B4F1-5B35D3C2BFBB}" dt="2021-03-25T05:34:40.773" v="73" actId="1076"/>
          <ac:spMkLst>
            <pc:docMk/>
            <pc:sldMk cId="1069951532" sldId="256"/>
            <ac:spMk id="8" creationId="{D958F705-E417-4925-8C40-876E50B9A357}"/>
          </ac:spMkLst>
        </pc:spChg>
        <pc:spChg chg="add mod">
          <ac:chgData name="Sarah Hill" userId="b774f213905f0ee8" providerId="LiveId" clId="{4D2644AF-49FD-466A-B4F1-5B35D3C2BFBB}" dt="2021-03-25T12:19:56.864" v="508" actId="1035"/>
          <ac:spMkLst>
            <pc:docMk/>
            <pc:sldMk cId="1069951532" sldId="256"/>
            <ac:spMk id="9" creationId="{F11DCB71-2AE4-4626-A0A8-F2BD8EE932DC}"/>
          </ac:spMkLst>
        </pc:spChg>
        <pc:picChg chg="add mod">
          <ac:chgData name="Sarah Hill" userId="b774f213905f0ee8" providerId="LiveId" clId="{4D2644AF-49FD-466A-B4F1-5B35D3C2BFBB}" dt="2021-03-25T05:34:44.010" v="75" actId="1076"/>
          <ac:picMkLst>
            <pc:docMk/>
            <pc:sldMk cId="1069951532" sldId="256"/>
            <ac:picMk id="5" creationId="{5875D68B-6B35-417C-A7A7-AB79B3FC03F2}"/>
          </ac:picMkLst>
        </pc:picChg>
      </pc:sldChg>
      <pc:sldChg chg="addSp modSp new mod">
        <pc:chgData name="Sarah Hill" userId="b774f213905f0ee8" providerId="LiveId" clId="{4D2644AF-49FD-466A-B4F1-5B35D3C2BFBB}" dt="2021-03-26T23:19:23.823" v="690" actId="20577"/>
        <pc:sldMkLst>
          <pc:docMk/>
          <pc:sldMk cId="2464832927" sldId="257"/>
        </pc:sldMkLst>
        <pc:spChg chg="add mod">
          <ac:chgData name="Sarah Hill" userId="b774f213905f0ee8" providerId="LiveId" clId="{4D2644AF-49FD-466A-B4F1-5B35D3C2BFBB}" dt="2021-03-25T13:09:16.277" v="667" actId="20577"/>
          <ac:spMkLst>
            <pc:docMk/>
            <pc:sldMk cId="2464832927" sldId="257"/>
            <ac:spMk id="2" creationId="{E8DA8C6F-64C1-48D8-8C2D-1162A49037EF}"/>
          </ac:spMkLst>
        </pc:spChg>
        <pc:spChg chg="add mod">
          <ac:chgData name="Sarah Hill" userId="b774f213905f0ee8" providerId="LiveId" clId="{4D2644AF-49FD-466A-B4F1-5B35D3C2BFBB}" dt="2021-03-25T05:39:17.675" v="245" actId="1076"/>
          <ac:spMkLst>
            <pc:docMk/>
            <pc:sldMk cId="2464832927" sldId="257"/>
            <ac:spMk id="3" creationId="{BE352305-47F8-4884-A17D-E607727D3BB4}"/>
          </ac:spMkLst>
        </pc:spChg>
        <pc:spChg chg="add mod">
          <ac:chgData name="Sarah Hill" userId="b774f213905f0ee8" providerId="LiveId" clId="{4D2644AF-49FD-466A-B4F1-5B35D3C2BFBB}" dt="2021-03-26T23:19:23.823" v="690" actId="20577"/>
          <ac:spMkLst>
            <pc:docMk/>
            <pc:sldMk cId="2464832927" sldId="257"/>
            <ac:spMk id="4" creationId="{26F36A61-6DD2-4168-95E9-88FD72595CE3}"/>
          </ac:spMkLst>
        </pc:spChg>
      </pc:sldChg>
      <pc:sldChg chg="addSp delSp modSp new mod">
        <pc:chgData name="Sarah Hill" userId="b774f213905f0ee8" providerId="LiveId" clId="{4D2644AF-49FD-466A-B4F1-5B35D3C2BFBB}" dt="2021-03-25T12:21:09.401" v="633" actId="478"/>
        <pc:sldMkLst>
          <pc:docMk/>
          <pc:sldMk cId="357471413" sldId="258"/>
        </pc:sldMkLst>
        <pc:spChg chg="add mod">
          <ac:chgData name="Sarah Hill" userId="b774f213905f0ee8" providerId="LiveId" clId="{4D2644AF-49FD-466A-B4F1-5B35D3C2BFBB}" dt="2021-03-25T05:38:50.497" v="221" actId="14100"/>
          <ac:spMkLst>
            <pc:docMk/>
            <pc:sldMk cId="357471413" sldId="258"/>
            <ac:spMk id="4" creationId="{474E163D-5453-48ED-B296-6A88C772668F}"/>
          </ac:spMkLst>
        </pc:spChg>
        <pc:spChg chg="add del mod">
          <ac:chgData name="Sarah Hill" userId="b774f213905f0ee8" providerId="LiveId" clId="{4D2644AF-49FD-466A-B4F1-5B35D3C2BFBB}" dt="2021-03-25T12:21:09.401" v="633" actId="478"/>
          <ac:spMkLst>
            <pc:docMk/>
            <pc:sldMk cId="357471413" sldId="258"/>
            <ac:spMk id="5" creationId="{37E4F55C-CEB5-449F-BCB1-35B32660220C}"/>
          </ac:spMkLst>
        </pc:spChg>
        <pc:spChg chg="add mod">
          <ac:chgData name="Sarah Hill" userId="b774f213905f0ee8" providerId="LiveId" clId="{4D2644AF-49FD-466A-B4F1-5B35D3C2BFBB}" dt="2021-03-25T05:39:01.983" v="236" actId="20577"/>
          <ac:spMkLst>
            <pc:docMk/>
            <pc:sldMk cId="357471413" sldId="258"/>
            <ac:spMk id="6" creationId="{E183AB69-2452-47F8-987C-476C3A72A6C8}"/>
          </ac:spMkLst>
        </pc:spChg>
        <pc:spChg chg="add mod">
          <ac:chgData name="Sarah Hill" userId="b774f213905f0ee8" providerId="LiveId" clId="{4D2644AF-49FD-466A-B4F1-5B35D3C2BFBB}" dt="2021-03-25T12:20:13.492" v="560" actId="1038"/>
          <ac:spMkLst>
            <pc:docMk/>
            <pc:sldMk cId="357471413" sldId="258"/>
            <ac:spMk id="7" creationId="{89822ACF-4F0F-4E79-AB67-C6A5EAAA281A}"/>
          </ac:spMkLst>
        </pc:spChg>
        <pc:picChg chg="add mod modCrop">
          <ac:chgData name="Sarah Hill" userId="b774f213905f0ee8" providerId="LiveId" clId="{4D2644AF-49FD-466A-B4F1-5B35D3C2BFBB}" dt="2021-03-25T05:38:28.038" v="218" actId="1076"/>
          <ac:picMkLst>
            <pc:docMk/>
            <pc:sldMk cId="357471413" sldId="258"/>
            <ac:picMk id="3" creationId="{A410CCD9-536B-4D15-9B47-D0C8A7C19CD7}"/>
          </ac:picMkLst>
        </pc:picChg>
      </pc:sldChg>
      <pc:sldChg chg="addSp delSp modSp new mod">
        <pc:chgData name="Sarah Hill" userId="b774f213905f0ee8" providerId="LiveId" clId="{4D2644AF-49FD-466A-B4F1-5B35D3C2BFBB}" dt="2021-03-25T12:20:47.198" v="599" actId="478"/>
        <pc:sldMkLst>
          <pc:docMk/>
          <pc:sldMk cId="1833549331" sldId="259"/>
        </pc:sldMkLst>
        <pc:spChg chg="add mod">
          <ac:chgData name="Sarah Hill" userId="b774f213905f0ee8" providerId="LiveId" clId="{4D2644AF-49FD-466A-B4F1-5B35D3C2BFBB}" dt="2021-03-25T05:43:14.648" v="339" actId="14100"/>
          <ac:spMkLst>
            <pc:docMk/>
            <pc:sldMk cId="1833549331" sldId="259"/>
            <ac:spMk id="4" creationId="{6217DCBD-F053-4650-9E4E-EF1A075B562D}"/>
          </ac:spMkLst>
        </pc:spChg>
        <pc:spChg chg="add del mod">
          <ac:chgData name="Sarah Hill" userId="b774f213905f0ee8" providerId="LiveId" clId="{4D2644AF-49FD-466A-B4F1-5B35D3C2BFBB}" dt="2021-03-25T12:20:47.198" v="599" actId="478"/>
          <ac:spMkLst>
            <pc:docMk/>
            <pc:sldMk cId="1833549331" sldId="259"/>
            <ac:spMk id="5" creationId="{6724E3DF-EB8E-4814-AB21-3968E5FF9917}"/>
          </ac:spMkLst>
        </pc:spChg>
        <pc:spChg chg="add mod">
          <ac:chgData name="Sarah Hill" userId="b774f213905f0ee8" providerId="LiveId" clId="{4D2644AF-49FD-466A-B4F1-5B35D3C2BFBB}" dt="2021-03-25T05:43:19.866" v="340" actId="1076"/>
          <ac:spMkLst>
            <pc:docMk/>
            <pc:sldMk cId="1833549331" sldId="259"/>
            <ac:spMk id="6" creationId="{FCDEA73F-07E8-4C1E-BAED-6E3147E1810E}"/>
          </ac:spMkLst>
        </pc:spChg>
        <pc:spChg chg="add mod">
          <ac:chgData name="Sarah Hill" userId="b774f213905f0ee8" providerId="LiveId" clId="{4D2644AF-49FD-466A-B4F1-5B35D3C2BFBB}" dt="2021-03-25T12:20:44.458" v="598" actId="1038"/>
          <ac:spMkLst>
            <pc:docMk/>
            <pc:sldMk cId="1833549331" sldId="259"/>
            <ac:spMk id="7" creationId="{8E81BDAE-7757-4E6E-8CA3-3C5497EB0273}"/>
          </ac:spMkLst>
        </pc:spChg>
        <pc:picChg chg="add mod modCrop">
          <ac:chgData name="Sarah Hill" userId="b774f213905f0ee8" providerId="LiveId" clId="{4D2644AF-49FD-466A-B4F1-5B35D3C2BFBB}" dt="2021-03-25T05:42:44.705" v="253" actId="1076"/>
          <ac:picMkLst>
            <pc:docMk/>
            <pc:sldMk cId="1833549331" sldId="259"/>
            <ac:picMk id="3" creationId="{4F647E6F-DCA0-47DB-81FF-5441B9EF7A90}"/>
          </ac:picMkLst>
        </pc:picChg>
      </pc:sldChg>
      <pc:sldChg chg="addSp delSp modSp new mod">
        <pc:chgData name="Sarah Hill" userId="b774f213905f0ee8" providerId="LiveId" clId="{4D2644AF-49FD-466A-B4F1-5B35D3C2BFBB}" dt="2021-03-25T12:20:59.979" v="630" actId="478"/>
        <pc:sldMkLst>
          <pc:docMk/>
          <pc:sldMk cId="1035926174" sldId="260"/>
        </pc:sldMkLst>
        <pc:spChg chg="add mod">
          <ac:chgData name="Sarah Hill" userId="b774f213905f0ee8" providerId="LiveId" clId="{4D2644AF-49FD-466A-B4F1-5B35D3C2BFBB}" dt="2021-03-25T05:44:11.550" v="381" actId="1036"/>
          <ac:spMkLst>
            <pc:docMk/>
            <pc:sldMk cId="1035926174" sldId="260"/>
            <ac:spMk id="4" creationId="{7E18B651-0FB2-4278-9646-5BBF86DBC20B}"/>
          </ac:spMkLst>
        </pc:spChg>
        <pc:spChg chg="add del mod">
          <ac:chgData name="Sarah Hill" userId="b774f213905f0ee8" providerId="LiveId" clId="{4D2644AF-49FD-466A-B4F1-5B35D3C2BFBB}" dt="2021-03-25T12:20:59.979" v="630" actId="478"/>
          <ac:spMkLst>
            <pc:docMk/>
            <pc:sldMk cId="1035926174" sldId="260"/>
            <ac:spMk id="5" creationId="{50CB0E4B-A899-417E-AC83-8A033E8753F9}"/>
          </ac:spMkLst>
        </pc:spChg>
        <pc:spChg chg="add mod">
          <ac:chgData name="Sarah Hill" userId="b774f213905f0ee8" providerId="LiveId" clId="{4D2644AF-49FD-466A-B4F1-5B35D3C2BFBB}" dt="2021-03-25T05:44:28.253" v="399" actId="20577"/>
          <ac:spMkLst>
            <pc:docMk/>
            <pc:sldMk cId="1035926174" sldId="260"/>
            <ac:spMk id="6" creationId="{998088F2-0D99-469C-853C-50F6A3DF5640}"/>
          </ac:spMkLst>
        </pc:spChg>
        <pc:spChg chg="add mod">
          <ac:chgData name="Sarah Hill" userId="b774f213905f0ee8" providerId="LiveId" clId="{4D2644AF-49FD-466A-B4F1-5B35D3C2BFBB}" dt="2021-03-25T12:20:57.602" v="629" actId="1038"/>
          <ac:spMkLst>
            <pc:docMk/>
            <pc:sldMk cId="1035926174" sldId="260"/>
            <ac:spMk id="7" creationId="{AED0B333-8FF6-471B-A505-76AC80BEF3D0}"/>
          </ac:spMkLst>
        </pc:spChg>
        <pc:picChg chg="add mod modCrop">
          <ac:chgData name="Sarah Hill" userId="b774f213905f0ee8" providerId="LiveId" clId="{4D2644AF-49FD-466A-B4F1-5B35D3C2BFBB}" dt="2021-03-25T05:43:56.624" v="347" actId="1076"/>
          <ac:picMkLst>
            <pc:docMk/>
            <pc:sldMk cId="1035926174" sldId="260"/>
            <ac:picMk id="3" creationId="{F25821A9-430F-4144-9D65-3A0478A36D87}"/>
          </ac:picMkLst>
        </pc:picChg>
      </pc:sldChg>
      <pc:sldChg chg="addSp modSp new mod">
        <pc:chgData name="Sarah Hill" userId="b774f213905f0ee8" providerId="LiveId" clId="{4D2644AF-49FD-466A-B4F1-5B35D3C2BFBB}" dt="2021-03-25T13:09:50.261" v="688" actId="20577"/>
        <pc:sldMkLst>
          <pc:docMk/>
          <pc:sldMk cId="551584944" sldId="261"/>
        </pc:sldMkLst>
        <pc:spChg chg="add mod">
          <ac:chgData name="Sarah Hill" userId="b774f213905f0ee8" providerId="LiveId" clId="{4D2644AF-49FD-466A-B4F1-5B35D3C2BFBB}" dt="2021-03-25T13:09:50.261" v="688" actId="20577"/>
          <ac:spMkLst>
            <pc:docMk/>
            <pc:sldMk cId="551584944" sldId="261"/>
            <ac:spMk id="2" creationId="{6266FD06-96EC-4323-83F9-D26A159B2F30}"/>
          </ac:spMkLst>
        </pc:spChg>
        <pc:spChg chg="add mod">
          <ac:chgData name="Sarah Hill" userId="b774f213905f0ee8" providerId="LiveId" clId="{4D2644AF-49FD-466A-B4F1-5B35D3C2BFBB}" dt="2021-03-25T05:46:05.291" v="485" actId="20577"/>
          <ac:spMkLst>
            <pc:docMk/>
            <pc:sldMk cId="551584944" sldId="261"/>
            <ac:spMk id="3" creationId="{F3C6D7DD-59B0-49B7-A8BF-8BE26BDF0333}"/>
          </ac:spMkLst>
        </pc:spChg>
      </pc:sldChg>
      <pc:sldMasterChg chg="modSp modSldLayout">
        <pc:chgData name="Sarah Hill" userId="b774f213905f0ee8" providerId="LiveId" clId="{4D2644AF-49FD-466A-B4F1-5B35D3C2BFBB}" dt="2021-03-25T05:32:01.630" v="0"/>
        <pc:sldMasterMkLst>
          <pc:docMk/>
          <pc:sldMasterMk cId="786800963" sldId="2147483648"/>
        </pc:sldMasterMkLst>
        <pc:spChg chg="mod">
          <ac:chgData name="Sarah Hill" userId="b774f213905f0ee8" providerId="LiveId" clId="{4D2644AF-49FD-466A-B4F1-5B35D3C2BFBB}" dt="2021-03-25T05:32:01.630" v="0"/>
          <ac:spMkLst>
            <pc:docMk/>
            <pc:sldMasterMk cId="786800963" sldId="2147483648"/>
            <ac:spMk id="2" creationId="{FBB6A303-0878-4CFE-BC83-2B7BAD80541E}"/>
          </ac:spMkLst>
        </pc:spChg>
        <pc:spChg chg="mod">
          <ac:chgData name="Sarah Hill" userId="b774f213905f0ee8" providerId="LiveId" clId="{4D2644AF-49FD-466A-B4F1-5B35D3C2BFBB}" dt="2021-03-25T05:32:01.630" v="0"/>
          <ac:spMkLst>
            <pc:docMk/>
            <pc:sldMasterMk cId="786800963" sldId="2147483648"/>
            <ac:spMk id="3" creationId="{5504338C-7A89-488A-92A7-66C24E3C9342}"/>
          </ac:spMkLst>
        </pc:spChg>
        <pc:spChg chg="mod">
          <ac:chgData name="Sarah Hill" userId="b774f213905f0ee8" providerId="LiveId" clId="{4D2644AF-49FD-466A-B4F1-5B35D3C2BFBB}" dt="2021-03-25T05:32:01.630" v="0"/>
          <ac:spMkLst>
            <pc:docMk/>
            <pc:sldMasterMk cId="786800963" sldId="2147483648"/>
            <ac:spMk id="4" creationId="{DCE0DE73-E40B-44A6-8E0D-B063BB6F0E68}"/>
          </ac:spMkLst>
        </pc:spChg>
        <pc:spChg chg="mod">
          <ac:chgData name="Sarah Hill" userId="b774f213905f0ee8" providerId="LiveId" clId="{4D2644AF-49FD-466A-B4F1-5B35D3C2BFBB}" dt="2021-03-25T05:32:01.630" v="0"/>
          <ac:spMkLst>
            <pc:docMk/>
            <pc:sldMasterMk cId="786800963" sldId="2147483648"/>
            <ac:spMk id="5" creationId="{535A170F-2AF2-48C8-95B7-BD155235A454}"/>
          </ac:spMkLst>
        </pc:spChg>
        <pc:spChg chg="mod">
          <ac:chgData name="Sarah Hill" userId="b774f213905f0ee8" providerId="LiveId" clId="{4D2644AF-49FD-466A-B4F1-5B35D3C2BFBB}" dt="2021-03-25T05:32:01.630" v="0"/>
          <ac:spMkLst>
            <pc:docMk/>
            <pc:sldMasterMk cId="786800963" sldId="2147483648"/>
            <ac:spMk id="6" creationId="{3F65B23B-A858-431A-BF5D-219F4482E32C}"/>
          </ac:spMkLst>
        </pc:spChg>
        <pc:sldLayoutChg chg="modSp">
          <pc:chgData name="Sarah Hill" userId="b774f213905f0ee8" providerId="LiveId" clId="{4D2644AF-49FD-466A-B4F1-5B35D3C2BFBB}" dt="2021-03-25T05:32:01.630" v="0"/>
          <pc:sldLayoutMkLst>
            <pc:docMk/>
            <pc:sldMasterMk cId="786800963" sldId="2147483648"/>
            <pc:sldLayoutMk cId="3315128907" sldId="2147483649"/>
          </pc:sldLayoutMkLst>
          <pc:spChg chg="mod">
            <ac:chgData name="Sarah Hill" userId="b774f213905f0ee8" providerId="LiveId" clId="{4D2644AF-49FD-466A-B4F1-5B35D3C2BFBB}" dt="2021-03-25T05:32:01.630" v="0"/>
            <ac:spMkLst>
              <pc:docMk/>
              <pc:sldMasterMk cId="786800963" sldId="2147483648"/>
              <pc:sldLayoutMk cId="3315128907" sldId="2147483649"/>
              <ac:spMk id="2" creationId="{50680D11-6791-4E42-94FD-AAFBCE6F472F}"/>
            </ac:spMkLst>
          </pc:spChg>
          <pc:spChg chg="mod">
            <ac:chgData name="Sarah Hill" userId="b774f213905f0ee8" providerId="LiveId" clId="{4D2644AF-49FD-466A-B4F1-5B35D3C2BFBB}" dt="2021-03-25T05:32:01.630" v="0"/>
            <ac:spMkLst>
              <pc:docMk/>
              <pc:sldMasterMk cId="786800963" sldId="2147483648"/>
              <pc:sldLayoutMk cId="3315128907" sldId="2147483649"/>
              <ac:spMk id="3" creationId="{A668E40F-2372-4E5B-951C-2AA559DE420D}"/>
            </ac:spMkLst>
          </pc:spChg>
        </pc:sldLayoutChg>
        <pc:sldLayoutChg chg="modSp">
          <pc:chgData name="Sarah Hill" userId="b774f213905f0ee8" providerId="LiveId" clId="{4D2644AF-49FD-466A-B4F1-5B35D3C2BFBB}" dt="2021-03-25T05:32:01.630" v="0"/>
          <pc:sldLayoutMkLst>
            <pc:docMk/>
            <pc:sldMasterMk cId="786800963" sldId="2147483648"/>
            <pc:sldLayoutMk cId="1384546399" sldId="2147483651"/>
          </pc:sldLayoutMkLst>
          <pc:spChg chg="mod">
            <ac:chgData name="Sarah Hill" userId="b774f213905f0ee8" providerId="LiveId" clId="{4D2644AF-49FD-466A-B4F1-5B35D3C2BFBB}" dt="2021-03-25T05:32:01.630" v="0"/>
            <ac:spMkLst>
              <pc:docMk/>
              <pc:sldMasterMk cId="786800963" sldId="2147483648"/>
              <pc:sldLayoutMk cId="1384546399" sldId="2147483651"/>
              <ac:spMk id="2" creationId="{6DD91D3E-E94D-40C0-BF41-E63D86E0538E}"/>
            </ac:spMkLst>
          </pc:spChg>
          <pc:spChg chg="mod">
            <ac:chgData name="Sarah Hill" userId="b774f213905f0ee8" providerId="LiveId" clId="{4D2644AF-49FD-466A-B4F1-5B35D3C2BFBB}" dt="2021-03-25T05:32:01.630" v="0"/>
            <ac:spMkLst>
              <pc:docMk/>
              <pc:sldMasterMk cId="786800963" sldId="2147483648"/>
              <pc:sldLayoutMk cId="1384546399" sldId="2147483651"/>
              <ac:spMk id="3" creationId="{DDFCD4B0-CA47-47F2-A283-10F5CFC3F9BF}"/>
            </ac:spMkLst>
          </pc:spChg>
        </pc:sldLayoutChg>
        <pc:sldLayoutChg chg="modSp">
          <pc:chgData name="Sarah Hill" userId="b774f213905f0ee8" providerId="LiveId" clId="{4D2644AF-49FD-466A-B4F1-5B35D3C2BFBB}" dt="2021-03-25T05:32:01.630" v="0"/>
          <pc:sldLayoutMkLst>
            <pc:docMk/>
            <pc:sldMasterMk cId="786800963" sldId="2147483648"/>
            <pc:sldLayoutMk cId="2953526158" sldId="2147483652"/>
          </pc:sldLayoutMkLst>
          <pc:spChg chg="mod">
            <ac:chgData name="Sarah Hill" userId="b774f213905f0ee8" providerId="LiveId" clId="{4D2644AF-49FD-466A-B4F1-5B35D3C2BFBB}" dt="2021-03-25T05:32:01.630" v="0"/>
            <ac:spMkLst>
              <pc:docMk/>
              <pc:sldMasterMk cId="786800963" sldId="2147483648"/>
              <pc:sldLayoutMk cId="2953526158" sldId="2147483652"/>
              <ac:spMk id="3" creationId="{7F11C951-CCDD-4EC7-9C2F-3363CFC1B810}"/>
            </ac:spMkLst>
          </pc:spChg>
          <pc:spChg chg="mod">
            <ac:chgData name="Sarah Hill" userId="b774f213905f0ee8" providerId="LiveId" clId="{4D2644AF-49FD-466A-B4F1-5B35D3C2BFBB}" dt="2021-03-25T05:32:01.630" v="0"/>
            <ac:spMkLst>
              <pc:docMk/>
              <pc:sldMasterMk cId="786800963" sldId="2147483648"/>
              <pc:sldLayoutMk cId="2953526158" sldId="2147483652"/>
              <ac:spMk id="4" creationId="{5947D9E0-0EA2-452D-A76B-06B028D80576}"/>
            </ac:spMkLst>
          </pc:spChg>
        </pc:sldLayoutChg>
        <pc:sldLayoutChg chg="modSp">
          <pc:chgData name="Sarah Hill" userId="b774f213905f0ee8" providerId="LiveId" clId="{4D2644AF-49FD-466A-B4F1-5B35D3C2BFBB}" dt="2021-03-25T05:32:01.630" v="0"/>
          <pc:sldLayoutMkLst>
            <pc:docMk/>
            <pc:sldMasterMk cId="786800963" sldId="2147483648"/>
            <pc:sldLayoutMk cId="280792536" sldId="2147483653"/>
          </pc:sldLayoutMkLst>
          <pc:spChg chg="mod">
            <ac:chgData name="Sarah Hill" userId="b774f213905f0ee8" providerId="LiveId" clId="{4D2644AF-49FD-466A-B4F1-5B35D3C2BFBB}" dt="2021-03-25T05:32:01.630" v="0"/>
            <ac:spMkLst>
              <pc:docMk/>
              <pc:sldMasterMk cId="786800963" sldId="2147483648"/>
              <pc:sldLayoutMk cId="280792536" sldId="2147483653"/>
              <ac:spMk id="2" creationId="{051CCA2F-9DC2-4BB3-88B9-929D470FFEC4}"/>
            </ac:spMkLst>
          </pc:spChg>
          <pc:spChg chg="mod">
            <ac:chgData name="Sarah Hill" userId="b774f213905f0ee8" providerId="LiveId" clId="{4D2644AF-49FD-466A-B4F1-5B35D3C2BFBB}" dt="2021-03-25T05:32:01.630" v="0"/>
            <ac:spMkLst>
              <pc:docMk/>
              <pc:sldMasterMk cId="786800963" sldId="2147483648"/>
              <pc:sldLayoutMk cId="280792536" sldId="2147483653"/>
              <ac:spMk id="3" creationId="{D7A9FD6E-6A10-4189-B665-E72E1A8070D4}"/>
            </ac:spMkLst>
          </pc:spChg>
          <pc:spChg chg="mod">
            <ac:chgData name="Sarah Hill" userId="b774f213905f0ee8" providerId="LiveId" clId="{4D2644AF-49FD-466A-B4F1-5B35D3C2BFBB}" dt="2021-03-25T05:32:01.630" v="0"/>
            <ac:spMkLst>
              <pc:docMk/>
              <pc:sldMasterMk cId="786800963" sldId="2147483648"/>
              <pc:sldLayoutMk cId="280792536" sldId="2147483653"/>
              <ac:spMk id="4" creationId="{7489030F-0575-483F-A373-2BD4FDB8386A}"/>
            </ac:spMkLst>
          </pc:spChg>
          <pc:spChg chg="mod">
            <ac:chgData name="Sarah Hill" userId="b774f213905f0ee8" providerId="LiveId" clId="{4D2644AF-49FD-466A-B4F1-5B35D3C2BFBB}" dt="2021-03-25T05:32:01.630" v="0"/>
            <ac:spMkLst>
              <pc:docMk/>
              <pc:sldMasterMk cId="786800963" sldId="2147483648"/>
              <pc:sldLayoutMk cId="280792536" sldId="2147483653"/>
              <ac:spMk id="5" creationId="{5ADFD378-0EA4-4DD3-80F0-6D12895B8022}"/>
            </ac:spMkLst>
          </pc:spChg>
          <pc:spChg chg="mod">
            <ac:chgData name="Sarah Hill" userId="b774f213905f0ee8" providerId="LiveId" clId="{4D2644AF-49FD-466A-B4F1-5B35D3C2BFBB}" dt="2021-03-25T05:32:01.630" v="0"/>
            <ac:spMkLst>
              <pc:docMk/>
              <pc:sldMasterMk cId="786800963" sldId="2147483648"/>
              <pc:sldLayoutMk cId="280792536" sldId="2147483653"/>
              <ac:spMk id="6" creationId="{605745AC-A84B-4235-ADC7-762AE17A65F1}"/>
            </ac:spMkLst>
          </pc:spChg>
        </pc:sldLayoutChg>
        <pc:sldLayoutChg chg="modSp">
          <pc:chgData name="Sarah Hill" userId="b774f213905f0ee8" providerId="LiveId" clId="{4D2644AF-49FD-466A-B4F1-5B35D3C2BFBB}" dt="2021-03-25T05:32:01.630" v="0"/>
          <pc:sldLayoutMkLst>
            <pc:docMk/>
            <pc:sldMasterMk cId="786800963" sldId="2147483648"/>
            <pc:sldLayoutMk cId="4254826088" sldId="2147483656"/>
          </pc:sldLayoutMkLst>
          <pc:spChg chg="mod">
            <ac:chgData name="Sarah Hill" userId="b774f213905f0ee8" providerId="LiveId" clId="{4D2644AF-49FD-466A-B4F1-5B35D3C2BFBB}" dt="2021-03-25T05:32:01.630" v="0"/>
            <ac:spMkLst>
              <pc:docMk/>
              <pc:sldMasterMk cId="786800963" sldId="2147483648"/>
              <pc:sldLayoutMk cId="4254826088" sldId="2147483656"/>
              <ac:spMk id="2" creationId="{4A242C91-2BE2-46DC-A80C-272489322844}"/>
            </ac:spMkLst>
          </pc:spChg>
          <pc:spChg chg="mod">
            <ac:chgData name="Sarah Hill" userId="b774f213905f0ee8" providerId="LiveId" clId="{4D2644AF-49FD-466A-B4F1-5B35D3C2BFBB}" dt="2021-03-25T05:32:01.630" v="0"/>
            <ac:spMkLst>
              <pc:docMk/>
              <pc:sldMasterMk cId="786800963" sldId="2147483648"/>
              <pc:sldLayoutMk cId="4254826088" sldId="2147483656"/>
              <ac:spMk id="3" creationId="{000D01CD-4758-4BE0-8F99-9F56B3C624DB}"/>
            </ac:spMkLst>
          </pc:spChg>
          <pc:spChg chg="mod">
            <ac:chgData name="Sarah Hill" userId="b774f213905f0ee8" providerId="LiveId" clId="{4D2644AF-49FD-466A-B4F1-5B35D3C2BFBB}" dt="2021-03-25T05:32:01.630" v="0"/>
            <ac:spMkLst>
              <pc:docMk/>
              <pc:sldMasterMk cId="786800963" sldId="2147483648"/>
              <pc:sldLayoutMk cId="4254826088" sldId="2147483656"/>
              <ac:spMk id="4" creationId="{E79018A4-C5CD-4755-8C36-E0EB5968C43C}"/>
            </ac:spMkLst>
          </pc:spChg>
        </pc:sldLayoutChg>
        <pc:sldLayoutChg chg="modSp">
          <pc:chgData name="Sarah Hill" userId="b774f213905f0ee8" providerId="LiveId" clId="{4D2644AF-49FD-466A-B4F1-5B35D3C2BFBB}" dt="2021-03-25T05:32:01.630" v="0"/>
          <pc:sldLayoutMkLst>
            <pc:docMk/>
            <pc:sldMasterMk cId="786800963" sldId="2147483648"/>
            <pc:sldLayoutMk cId="2661004444" sldId="2147483657"/>
          </pc:sldLayoutMkLst>
          <pc:spChg chg="mod">
            <ac:chgData name="Sarah Hill" userId="b774f213905f0ee8" providerId="LiveId" clId="{4D2644AF-49FD-466A-B4F1-5B35D3C2BFBB}" dt="2021-03-25T05:32:01.630" v="0"/>
            <ac:spMkLst>
              <pc:docMk/>
              <pc:sldMasterMk cId="786800963" sldId="2147483648"/>
              <pc:sldLayoutMk cId="2661004444" sldId="2147483657"/>
              <ac:spMk id="2" creationId="{546FCCBD-5E10-4EF2-ADF3-16932A71DF1F}"/>
            </ac:spMkLst>
          </pc:spChg>
          <pc:spChg chg="mod">
            <ac:chgData name="Sarah Hill" userId="b774f213905f0ee8" providerId="LiveId" clId="{4D2644AF-49FD-466A-B4F1-5B35D3C2BFBB}" dt="2021-03-25T05:32:01.630" v="0"/>
            <ac:spMkLst>
              <pc:docMk/>
              <pc:sldMasterMk cId="786800963" sldId="2147483648"/>
              <pc:sldLayoutMk cId="2661004444" sldId="2147483657"/>
              <ac:spMk id="3" creationId="{D62C5424-221B-4F7C-98EE-21E7102D1037}"/>
            </ac:spMkLst>
          </pc:spChg>
          <pc:spChg chg="mod">
            <ac:chgData name="Sarah Hill" userId="b774f213905f0ee8" providerId="LiveId" clId="{4D2644AF-49FD-466A-B4F1-5B35D3C2BFBB}" dt="2021-03-25T05:32:01.630" v="0"/>
            <ac:spMkLst>
              <pc:docMk/>
              <pc:sldMasterMk cId="786800963" sldId="2147483648"/>
              <pc:sldLayoutMk cId="2661004444" sldId="2147483657"/>
              <ac:spMk id="4" creationId="{77FFDC50-97E0-4400-A455-1A2BF109D01A}"/>
            </ac:spMkLst>
          </pc:spChg>
        </pc:sldLayoutChg>
        <pc:sldLayoutChg chg="modSp">
          <pc:chgData name="Sarah Hill" userId="b774f213905f0ee8" providerId="LiveId" clId="{4D2644AF-49FD-466A-B4F1-5B35D3C2BFBB}" dt="2021-03-25T05:32:01.630" v="0"/>
          <pc:sldLayoutMkLst>
            <pc:docMk/>
            <pc:sldMasterMk cId="786800963" sldId="2147483648"/>
            <pc:sldLayoutMk cId="2969156373" sldId="2147483659"/>
          </pc:sldLayoutMkLst>
          <pc:spChg chg="mod">
            <ac:chgData name="Sarah Hill" userId="b774f213905f0ee8" providerId="LiveId" clId="{4D2644AF-49FD-466A-B4F1-5B35D3C2BFBB}" dt="2021-03-25T05:32:01.630" v="0"/>
            <ac:spMkLst>
              <pc:docMk/>
              <pc:sldMasterMk cId="786800963" sldId="2147483648"/>
              <pc:sldLayoutMk cId="2969156373" sldId="2147483659"/>
              <ac:spMk id="2" creationId="{56CC31E5-753A-40C6-9B93-CC992AFB817E}"/>
            </ac:spMkLst>
          </pc:spChg>
          <pc:spChg chg="mod">
            <ac:chgData name="Sarah Hill" userId="b774f213905f0ee8" providerId="LiveId" clId="{4D2644AF-49FD-466A-B4F1-5B35D3C2BFBB}" dt="2021-03-25T05:32:01.630" v="0"/>
            <ac:spMkLst>
              <pc:docMk/>
              <pc:sldMasterMk cId="786800963" sldId="2147483648"/>
              <pc:sldLayoutMk cId="2969156373" sldId="2147483659"/>
              <ac:spMk id="3" creationId="{78A1CD4C-0EBA-497A-B0BF-F229735B0134}"/>
            </ac:spMkLst>
          </pc:spChg>
        </pc:sldLayoutChg>
      </pc:sldMaster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1E7B2-EA69-43F9-816E-CF6798DBB439}" type="datetimeFigureOut">
              <a:rPr lang="en-US" smtClean="0"/>
              <a:t>3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295A1-CB42-4C10-9C64-303F16DA62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65398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1E7B2-EA69-43F9-816E-CF6798DBB439}" type="datetimeFigureOut">
              <a:rPr lang="en-US" smtClean="0"/>
              <a:t>3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295A1-CB42-4C10-9C64-303F16DA62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94826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1E7B2-EA69-43F9-816E-CF6798DBB439}" type="datetimeFigureOut">
              <a:rPr lang="en-US" smtClean="0"/>
              <a:t>3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295A1-CB42-4C10-9C64-303F16DA62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4248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1E7B2-EA69-43F9-816E-CF6798DBB439}" type="datetimeFigureOut">
              <a:rPr lang="en-US" smtClean="0"/>
              <a:t>3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295A1-CB42-4C10-9C64-303F16DA62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3055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1E7B2-EA69-43F9-816E-CF6798DBB439}" type="datetimeFigureOut">
              <a:rPr lang="en-US" smtClean="0"/>
              <a:t>3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295A1-CB42-4C10-9C64-303F16DA62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90632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1E7B2-EA69-43F9-816E-CF6798DBB439}" type="datetimeFigureOut">
              <a:rPr lang="en-US" smtClean="0"/>
              <a:t>3/2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295A1-CB42-4C10-9C64-303F16DA62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87374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1E7B2-EA69-43F9-816E-CF6798DBB439}" type="datetimeFigureOut">
              <a:rPr lang="en-US" smtClean="0"/>
              <a:t>3/26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295A1-CB42-4C10-9C64-303F16DA62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19038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1E7B2-EA69-43F9-816E-CF6798DBB439}" type="datetimeFigureOut">
              <a:rPr lang="en-US" smtClean="0"/>
              <a:t>3/26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295A1-CB42-4C10-9C64-303F16DA62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72052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1E7B2-EA69-43F9-816E-CF6798DBB439}" type="datetimeFigureOut">
              <a:rPr lang="en-US" smtClean="0"/>
              <a:t>3/26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295A1-CB42-4C10-9C64-303F16DA62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5910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1E7B2-EA69-43F9-816E-CF6798DBB439}" type="datetimeFigureOut">
              <a:rPr lang="en-US" smtClean="0"/>
              <a:t>3/2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295A1-CB42-4C10-9C64-303F16DA62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75244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1E7B2-EA69-43F9-816E-CF6798DBB439}" type="datetimeFigureOut">
              <a:rPr lang="en-US" smtClean="0"/>
              <a:t>3/2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295A1-CB42-4C10-9C64-303F16DA62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88114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C1E7B2-EA69-43F9-816E-CF6798DBB439}" type="datetimeFigureOut">
              <a:rPr lang="en-US" smtClean="0"/>
              <a:t>3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3295A1-CB42-4C10-9C64-303F16DA62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25824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8DA8C6F-64C1-48D8-8C2D-1162A49037EF}"/>
              </a:ext>
            </a:extLst>
          </p:cNvPr>
          <p:cNvSpPr txBox="1"/>
          <p:nvPr/>
        </p:nvSpPr>
        <p:spPr>
          <a:xfrm>
            <a:off x="1031630" y="1946031"/>
            <a:ext cx="479473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3C ARK1 sip53 Gel loading order, please see order below and boxed areas on following slide.</a:t>
            </a:r>
          </a:p>
          <a:p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E352305-47F8-4884-A17D-E607727D3BB4}"/>
              </a:ext>
            </a:extLst>
          </p:cNvPr>
          <p:cNvSpPr txBox="1"/>
          <p:nvPr/>
        </p:nvSpPr>
        <p:spPr>
          <a:xfrm rot="16200000">
            <a:off x="691660" y="1853698"/>
            <a:ext cx="4794739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 Ladder</a:t>
            </a:r>
          </a:p>
          <a:p>
            <a:r>
              <a:rPr lang="en-US" dirty="0"/>
              <a:t>2 ARK1 siControl</a:t>
            </a:r>
          </a:p>
          <a:p>
            <a:r>
              <a:rPr lang="en-US" dirty="0"/>
              <a:t>3 ARK1 sip53-5</a:t>
            </a:r>
          </a:p>
          <a:p>
            <a:r>
              <a:rPr lang="en-US" dirty="0"/>
              <a:t>4 ARK1 sip53-7 </a:t>
            </a:r>
          </a:p>
          <a:p>
            <a:r>
              <a:rPr lang="en-US" dirty="0"/>
              <a:t>5 not the gel</a:t>
            </a:r>
          </a:p>
          <a:p>
            <a:r>
              <a:rPr lang="en-US" dirty="0"/>
              <a:t>6 not this gel</a:t>
            </a:r>
          </a:p>
          <a:p>
            <a:r>
              <a:rPr lang="en-US" dirty="0"/>
              <a:t>7 not this gel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6F36A61-6DD2-4168-95E9-88FD72595CE3}"/>
              </a:ext>
            </a:extLst>
          </p:cNvPr>
          <p:cNvSpPr txBox="1"/>
          <p:nvPr/>
        </p:nvSpPr>
        <p:spPr>
          <a:xfrm>
            <a:off x="586154" y="339969"/>
            <a:ext cx="586153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or all blots specific to the figure, we have placed a box around the full western of interest and placed the lane numbers below. It.</a:t>
            </a:r>
          </a:p>
        </p:txBody>
      </p:sp>
    </p:spTree>
    <p:extLst>
      <p:ext uri="{BB962C8B-B14F-4D97-AF65-F5344CB8AC3E}">
        <p14:creationId xmlns:p14="http://schemas.microsoft.com/office/powerpoint/2010/main" val="24648329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ece of paper with writing on it&#10;&#10;Description automatically generated">
            <a:extLst>
              <a:ext uri="{FF2B5EF4-FFF2-40B4-BE49-F238E27FC236}">
                <a16:creationId xmlns:a16="http://schemas.microsoft.com/office/drawing/2014/main" id="{5875D68B-6B35-417C-A7A7-AB79B3FC03F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54811"/>
            <a:ext cx="6858000" cy="8595669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6F8F25D2-4CD1-4860-895F-6E960C95043B}"/>
              </a:ext>
            </a:extLst>
          </p:cNvPr>
          <p:cNvSpPr/>
          <p:nvPr/>
        </p:nvSpPr>
        <p:spPr>
          <a:xfrm>
            <a:off x="2145324" y="1064464"/>
            <a:ext cx="1055078" cy="186396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958F705-E417-4925-8C40-876E50B9A357}"/>
              </a:ext>
            </a:extLst>
          </p:cNvPr>
          <p:cNvSpPr txBox="1"/>
          <p:nvPr/>
        </p:nvSpPr>
        <p:spPr>
          <a:xfrm>
            <a:off x="2373922" y="695132"/>
            <a:ext cx="10550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5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11DCB71-2AE4-4626-A0A8-F2BD8EE932DC}"/>
              </a:ext>
            </a:extLst>
          </p:cNvPr>
          <p:cNvSpPr txBox="1"/>
          <p:nvPr/>
        </p:nvSpPr>
        <p:spPr>
          <a:xfrm>
            <a:off x="2373922" y="2649978"/>
            <a:ext cx="10550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-2-3-4</a:t>
            </a:r>
          </a:p>
        </p:txBody>
      </p:sp>
    </p:spTree>
    <p:extLst>
      <p:ext uri="{BB962C8B-B14F-4D97-AF65-F5344CB8AC3E}">
        <p14:creationId xmlns:p14="http://schemas.microsoft.com/office/powerpoint/2010/main" val="10699515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, schematic&#10;&#10;Description automatically generated">
            <a:extLst>
              <a:ext uri="{FF2B5EF4-FFF2-40B4-BE49-F238E27FC236}">
                <a16:creationId xmlns:a16="http://schemas.microsoft.com/office/drawing/2014/main" id="{A410CCD9-536B-4D15-9B47-D0C8A7C19CD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1637"/>
          <a:stretch/>
        </p:blipFill>
        <p:spPr>
          <a:xfrm rot="5400000">
            <a:off x="0" y="3122874"/>
            <a:ext cx="6858000" cy="4157158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474E163D-5453-48ED-B296-6A88C772668F}"/>
              </a:ext>
            </a:extLst>
          </p:cNvPr>
          <p:cNvSpPr/>
          <p:nvPr/>
        </p:nvSpPr>
        <p:spPr>
          <a:xfrm>
            <a:off x="4196862" y="1498218"/>
            <a:ext cx="527540" cy="186396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183AB69-2452-47F8-987C-476C3A72A6C8}"/>
              </a:ext>
            </a:extLst>
          </p:cNvPr>
          <p:cNvSpPr txBox="1"/>
          <p:nvPr/>
        </p:nvSpPr>
        <p:spPr>
          <a:xfrm>
            <a:off x="4196862" y="1226231"/>
            <a:ext cx="10550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Vinculin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9822ACF-4F0F-4E79-AB67-C6A5EAAA281A}"/>
              </a:ext>
            </a:extLst>
          </p:cNvPr>
          <p:cNvSpPr txBox="1"/>
          <p:nvPr/>
        </p:nvSpPr>
        <p:spPr>
          <a:xfrm>
            <a:off x="3979979" y="2837546"/>
            <a:ext cx="10550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-2-3-4</a:t>
            </a:r>
          </a:p>
        </p:txBody>
      </p:sp>
    </p:spTree>
    <p:extLst>
      <p:ext uri="{BB962C8B-B14F-4D97-AF65-F5344CB8AC3E}">
        <p14:creationId xmlns:p14="http://schemas.microsoft.com/office/powerpoint/2010/main" val="3574714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266FD06-96EC-4323-83F9-D26A159B2F30}"/>
              </a:ext>
            </a:extLst>
          </p:cNvPr>
          <p:cNvSpPr txBox="1"/>
          <p:nvPr/>
        </p:nvSpPr>
        <p:spPr>
          <a:xfrm>
            <a:off x="1031630" y="1946031"/>
            <a:ext cx="479473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3C HEC1B sip53 Gel loading order, please see order below and boxed areas on following slide.</a:t>
            </a:r>
          </a:p>
          <a:p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3C6D7DD-59B0-49B7-A8BF-8BE26BDF0333}"/>
              </a:ext>
            </a:extLst>
          </p:cNvPr>
          <p:cNvSpPr txBox="1"/>
          <p:nvPr/>
        </p:nvSpPr>
        <p:spPr>
          <a:xfrm rot="16200000">
            <a:off x="785445" y="3919137"/>
            <a:ext cx="4794739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 Ladder</a:t>
            </a:r>
          </a:p>
          <a:p>
            <a:r>
              <a:rPr lang="en-US" dirty="0"/>
              <a:t>2 not this gel </a:t>
            </a:r>
          </a:p>
          <a:p>
            <a:r>
              <a:rPr lang="en-US" dirty="0"/>
              <a:t>3 not this gel </a:t>
            </a:r>
          </a:p>
          <a:p>
            <a:r>
              <a:rPr lang="en-US" dirty="0"/>
              <a:t>4 not this gel</a:t>
            </a:r>
          </a:p>
          <a:p>
            <a:r>
              <a:rPr lang="en-US" dirty="0"/>
              <a:t>5 not the gel</a:t>
            </a:r>
          </a:p>
          <a:p>
            <a:r>
              <a:rPr lang="en-US" dirty="0"/>
              <a:t>6 HEC1B </a:t>
            </a:r>
            <a:r>
              <a:rPr lang="en-US" dirty="0" err="1"/>
              <a:t>siCONTROL</a:t>
            </a:r>
            <a:endParaRPr lang="en-US" dirty="0"/>
          </a:p>
          <a:p>
            <a:r>
              <a:rPr lang="en-US" dirty="0"/>
              <a:t>7 HEC1B sip53 5</a:t>
            </a:r>
          </a:p>
          <a:p>
            <a:r>
              <a:rPr lang="en-US" dirty="0"/>
              <a:t>8 HEC1B sip53 7</a:t>
            </a:r>
          </a:p>
        </p:txBody>
      </p:sp>
    </p:spTree>
    <p:extLst>
      <p:ext uri="{BB962C8B-B14F-4D97-AF65-F5344CB8AC3E}">
        <p14:creationId xmlns:p14="http://schemas.microsoft.com/office/powerpoint/2010/main" val="55158494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, engineering drawing&#10;&#10;Description automatically generated">
            <a:extLst>
              <a:ext uri="{FF2B5EF4-FFF2-40B4-BE49-F238E27FC236}">
                <a16:creationId xmlns:a16="http://schemas.microsoft.com/office/drawing/2014/main" id="{4F647E6F-DCA0-47DB-81FF-5441B9EF7A9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2950"/>
          <a:stretch/>
        </p:blipFill>
        <p:spPr>
          <a:xfrm rot="16200000">
            <a:off x="-222737" y="1947534"/>
            <a:ext cx="6858000" cy="4300865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6217DCBD-F053-4650-9E4E-EF1A075B562D}"/>
              </a:ext>
            </a:extLst>
          </p:cNvPr>
          <p:cNvSpPr/>
          <p:nvPr/>
        </p:nvSpPr>
        <p:spPr>
          <a:xfrm>
            <a:off x="3059730" y="4794738"/>
            <a:ext cx="527540" cy="121686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CDEA73F-07E8-4C1E-BAED-6E3147E1810E}"/>
              </a:ext>
            </a:extLst>
          </p:cNvPr>
          <p:cNvSpPr txBox="1"/>
          <p:nvPr/>
        </p:nvSpPr>
        <p:spPr>
          <a:xfrm>
            <a:off x="3059731" y="4425406"/>
            <a:ext cx="10550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53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E81BDAE-7757-4E6E-8CA3-3C5497EB0273}"/>
              </a:ext>
            </a:extLst>
          </p:cNvPr>
          <p:cNvSpPr txBox="1"/>
          <p:nvPr/>
        </p:nvSpPr>
        <p:spPr>
          <a:xfrm>
            <a:off x="2995252" y="6295094"/>
            <a:ext cx="10550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-7-8</a:t>
            </a:r>
          </a:p>
        </p:txBody>
      </p:sp>
    </p:spTree>
    <p:extLst>
      <p:ext uri="{BB962C8B-B14F-4D97-AF65-F5344CB8AC3E}">
        <p14:creationId xmlns:p14="http://schemas.microsoft.com/office/powerpoint/2010/main" val="183354933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, schematic&#10;&#10;Description automatically generated">
            <a:extLst>
              <a:ext uri="{FF2B5EF4-FFF2-40B4-BE49-F238E27FC236}">
                <a16:creationId xmlns:a16="http://schemas.microsoft.com/office/drawing/2014/main" id="{F25821A9-430F-4144-9D65-3A0478A36D8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1330"/>
          <a:stretch/>
        </p:blipFill>
        <p:spPr>
          <a:xfrm rot="5400000">
            <a:off x="-93784" y="2426581"/>
            <a:ext cx="6858000" cy="4290838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7E18B651-0FB2-4278-9646-5BBF86DBC20B}"/>
              </a:ext>
            </a:extLst>
          </p:cNvPr>
          <p:cNvSpPr/>
          <p:nvPr/>
        </p:nvSpPr>
        <p:spPr>
          <a:xfrm>
            <a:off x="3282467" y="4583724"/>
            <a:ext cx="527540" cy="121686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98088F2-0D99-469C-853C-50F6A3DF5640}"/>
              </a:ext>
            </a:extLst>
          </p:cNvPr>
          <p:cNvSpPr txBox="1"/>
          <p:nvPr/>
        </p:nvSpPr>
        <p:spPr>
          <a:xfrm>
            <a:off x="3282468" y="4214392"/>
            <a:ext cx="10550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Vinculin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ED0B333-8FF6-471B-A505-76AC80BEF3D0}"/>
              </a:ext>
            </a:extLst>
          </p:cNvPr>
          <p:cNvSpPr txBox="1"/>
          <p:nvPr/>
        </p:nvSpPr>
        <p:spPr>
          <a:xfrm>
            <a:off x="3241435" y="5814451"/>
            <a:ext cx="10550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-7-8</a:t>
            </a:r>
          </a:p>
        </p:txBody>
      </p:sp>
    </p:spTree>
    <p:extLst>
      <p:ext uri="{BB962C8B-B14F-4D97-AF65-F5344CB8AC3E}">
        <p14:creationId xmlns:p14="http://schemas.microsoft.com/office/powerpoint/2010/main" val="10359261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26</Words>
  <Application>Microsoft Office PowerPoint</Application>
  <PresentationFormat>Letter Paper (8.5x11 in)</PresentationFormat>
  <Paragraphs>2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h Hill</dc:creator>
  <cp:lastModifiedBy>Sarah Hill</cp:lastModifiedBy>
  <cp:revision>1</cp:revision>
  <dcterms:created xsi:type="dcterms:W3CDTF">2021-03-25T05:31:45Z</dcterms:created>
  <dcterms:modified xsi:type="dcterms:W3CDTF">2021-03-26T23:19:25Z</dcterms:modified>
</cp:coreProperties>
</file>